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124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576" y="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dhikari\OneDrive%20-%20North%20Carolina%20State%20University\Desktop\DEG_Tabl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6918333600883441E-2"/>
          <c:y val="8.9700042247570763E-2"/>
          <c:w val="0.88839620328610525"/>
          <c:h val="0.8325644275454161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56</c:f>
              <c:strCache>
                <c:ptCount val="55"/>
                <c:pt idx="0">
                  <c:v>AP2</c:v>
                </c:pt>
                <c:pt idx="1">
                  <c:v>ARF</c:v>
                </c:pt>
                <c:pt idx="2">
                  <c:v>ARR-B</c:v>
                </c:pt>
                <c:pt idx="3">
                  <c:v>B3</c:v>
                </c:pt>
                <c:pt idx="4">
                  <c:v>BBR-BPC</c:v>
                </c:pt>
                <c:pt idx="5">
                  <c:v>BES1</c:v>
                </c:pt>
                <c:pt idx="6">
                  <c:v>bHLH</c:v>
                </c:pt>
                <c:pt idx="7">
                  <c:v>bZIP</c:v>
                </c:pt>
                <c:pt idx="8">
                  <c:v>C2H2</c:v>
                </c:pt>
                <c:pt idx="9">
                  <c:v>C3H</c:v>
                </c:pt>
                <c:pt idx="10">
                  <c:v>CAMTA</c:v>
                </c:pt>
                <c:pt idx="11">
                  <c:v>CO-like</c:v>
                </c:pt>
                <c:pt idx="12">
                  <c:v>CPP</c:v>
                </c:pt>
                <c:pt idx="13">
                  <c:v>DBB</c:v>
                </c:pt>
                <c:pt idx="14">
                  <c:v>Dof</c:v>
                </c:pt>
                <c:pt idx="15">
                  <c:v>E2F/DP</c:v>
                </c:pt>
                <c:pt idx="16">
                  <c:v>EIL</c:v>
                </c:pt>
                <c:pt idx="17">
                  <c:v>ERF</c:v>
                </c:pt>
                <c:pt idx="18">
                  <c:v>FAR1</c:v>
                </c:pt>
                <c:pt idx="19">
                  <c:v>G2-like</c:v>
                </c:pt>
                <c:pt idx="20">
                  <c:v>GATA</c:v>
                </c:pt>
                <c:pt idx="21">
                  <c:v>GeBP</c:v>
                </c:pt>
                <c:pt idx="22">
                  <c:v>GRAS</c:v>
                </c:pt>
                <c:pt idx="23">
                  <c:v>GRF</c:v>
                </c:pt>
                <c:pt idx="24">
                  <c:v>HB-other</c:v>
                </c:pt>
                <c:pt idx="25">
                  <c:v>HD-ZIP</c:v>
                </c:pt>
                <c:pt idx="26">
                  <c:v>HRT-like</c:v>
                </c:pt>
                <c:pt idx="27">
                  <c:v>HSF</c:v>
                </c:pt>
                <c:pt idx="28">
                  <c:v>LBD</c:v>
                </c:pt>
                <c:pt idx="29">
                  <c:v>LFY</c:v>
                </c:pt>
                <c:pt idx="30">
                  <c:v>LSD</c:v>
                </c:pt>
                <c:pt idx="31">
                  <c:v>MIKC_MADS</c:v>
                </c:pt>
                <c:pt idx="32">
                  <c:v>M-type_MADS</c:v>
                </c:pt>
                <c:pt idx="33">
                  <c:v>MYB</c:v>
                </c:pt>
                <c:pt idx="34">
                  <c:v>MYB_related</c:v>
                </c:pt>
                <c:pt idx="35">
                  <c:v>NAC</c:v>
                </c:pt>
                <c:pt idx="36">
                  <c:v>NF-X1</c:v>
                </c:pt>
                <c:pt idx="37">
                  <c:v>NF-YA</c:v>
                </c:pt>
                <c:pt idx="38">
                  <c:v>NF-YB</c:v>
                </c:pt>
                <c:pt idx="39">
                  <c:v>NF-YC</c:v>
                </c:pt>
                <c:pt idx="40">
                  <c:v>Nin-like</c:v>
                </c:pt>
                <c:pt idx="41">
                  <c:v>NZZ/SPL</c:v>
                </c:pt>
                <c:pt idx="42">
                  <c:v>RAV</c:v>
                </c:pt>
                <c:pt idx="43">
                  <c:v>SBP</c:v>
                </c:pt>
                <c:pt idx="44">
                  <c:v>SRS</c:v>
                </c:pt>
                <c:pt idx="45">
                  <c:v>STAT</c:v>
                </c:pt>
                <c:pt idx="46">
                  <c:v>TALE</c:v>
                </c:pt>
                <c:pt idx="47">
                  <c:v>TCP</c:v>
                </c:pt>
                <c:pt idx="48">
                  <c:v>Trihelix</c:v>
                </c:pt>
                <c:pt idx="49">
                  <c:v>VOZ</c:v>
                </c:pt>
                <c:pt idx="50">
                  <c:v>Whirly</c:v>
                </c:pt>
                <c:pt idx="51">
                  <c:v>WOX</c:v>
                </c:pt>
                <c:pt idx="52">
                  <c:v>WRKY</c:v>
                </c:pt>
                <c:pt idx="53">
                  <c:v>YABBY</c:v>
                </c:pt>
                <c:pt idx="54">
                  <c:v>ZF-HD</c:v>
                </c:pt>
              </c:strCache>
            </c:strRef>
          </c:cat>
          <c:val>
            <c:numRef>
              <c:f>Sheet2!$B$2:$B$56</c:f>
              <c:numCache>
                <c:formatCode>General</c:formatCode>
                <c:ptCount val="55"/>
                <c:pt idx="0">
                  <c:v>13</c:v>
                </c:pt>
                <c:pt idx="1">
                  <c:v>16</c:v>
                </c:pt>
                <c:pt idx="2">
                  <c:v>10</c:v>
                </c:pt>
                <c:pt idx="3">
                  <c:v>38</c:v>
                </c:pt>
                <c:pt idx="4">
                  <c:v>3</c:v>
                </c:pt>
                <c:pt idx="5">
                  <c:v>6</c:v>
                </c:pt>
                <c:pt idx="6">
                  <c:v>82</c:v>
                </c:pt>
                <c:pt idx="7">
                  <c:v>37</c:v>
                </c:pt>
                <c:pt idx="8">
                  <c:v>66</c:v>
                </c:pt>
                <c:pt idx="9">
                  <c:v>44</c:v>
                </c:pt>
                <c:pt idx="10">
                  <c:v>4</c:v>
                </c:pt>
                <c:pt idx="11">
                  <c:v>5</c:v>
                </c:pt>
                <c:pt idx="12">
                  <c:v>2</c:v>
                </c:pt>
                <c:pt idx="13">
                  <c:v>8</c:v>
                </c:pt>
                <c:pt idx="14">
                  <c:v>19</c:v>
                </c:pt>
                <c:pt idx="15">
                  <c:v>5</c:v>
                </c:pt>
                <c:pt idx="16">
                  <c:v>4</c:v>
                </c:pt>
                <c:pt idx="17">
                  <c:v>76</c:v>
                </c:pt>
                <c:pt idx="18">
                  <c:v>55</c:v>
                </c:pt>
                <c:pt idx="19">
                  <c:v>26</c:v>
                </c:pt>
                <c:pt idx="20">
                  <c:v>15</c:v>
                </c:pt>
                <c:pt idx="21">
                  <c:v>5</c:v>
                </c:pt>
                <c:pt idx="22">
                  <c:v>45</c:v>
                </c:pt>
                <c:pt idx="23">
                  <c:v>9</c:v>
                </c:pt>
                <c:pt idx="24">
                  <c:v>5</c:v>
                </c:pt>
                <c:pt idx="25">
                  <c:v>26</c:v>
                </c:pt>
                <c:pt idx="26">
                  <c:v>3</c:v>
                </c:pt>
                <c:pt idx="27">
                  <c:v>14</c:v>
                </c:pt>
                <c:pt idx="28">
                  <c:v>21</c:v>
                </c:pt>
                <c:pt idx="29">
                  <c:v>2</c:v>
                </c:pt>
                <c:pt idx="30">
                  <c:v>3</c:v>
                </c:pt>
                <c:pt idx="31">
                  <c:v>4</c:v>
                </c:pt>
                <c:pt idx="32">
                  <c:v>15</c:v>
                </c:pt>
                <c:pt idx="33">
                  <c:v>75</c:v>
                </c:pt>
                <c:pt idx="34">
                  <c:v>50</c:v>
                </c:pt>
                <c:pt idx="35">
                  <c:v>75</c:v>
                </c:pt>
                <c:pt idx="36">
                  <c:v>1</c:v>
                </c:pt>
                <c:pt idx="37">
                  <c:v>8</c:v>
                </c:pt>
                <c:pt idx="38">
                  <c:v>7</c:v>
                </c:pt>
                <c:pt idx="39">
                  <c:v>8</c:v>
                </c:pt>
                <c:pt idx="40">
                  <c:v>7</c:v>
                </c:pt>
                <c:pt idx="41">
                  <c:v>1</c:v>
                </c:pt>
                <c:pt idx="42">
                  <c:v>1</c:v>
                </c:pt>
                <c:pt idx="43">
                  <c:v>12</c:v>
                </c:pt>
                <c:pt idx="44">
                  <c:v>3</c:v>
                </c:pt>
                <c:pt idx="45">
                  <c:v>1</c:v>
                </c:pt>
                <c:pt idx="46">
                  <c:v>13</c:v>
                </c:pt>
                <c:pt idx="47">
                  <c:v>16</c:v>
                </c:pt>
                <c:pt idx="48">
                  <c:v>32</c:v>
                </c:pt>
                <c:pt idx="49">
                  <c:v>1</c:v>
                </c:pt>
                <c:pt idx="50">
                  <c:v>4</c:v>
                </c:pt>
                <c:pt idx="51">
                  <c:v>7</c:v>
                </c:pt>
                <c:pt idx="52">
                  <c:v>61</c:v>
                </c:pt>
                <c:pt idx="53">
                  <c:v>5</c:v>
                </c:pt>
                <c:pt idx="5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B2D-4DFD-B000-DFE3AEEB55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924113480"/>
        <c:axId val="924111840"/>
      </c:barChart>
      <c:catAx>
        <c:axId val="924113480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317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924111840"/>
        <c:crosses val="autoZero"/>
        <c:auto val="1"/>
        <c:lblAlgn val="ctr"/>
        <c:lblOffset val="100"/>
        <c:noMultiLvlLbl val="0"/>
      </c:catAx>
      <c:valAx>
        <c:axId val="924111840"/>
        <c:scaling>
          <c:orientation val="minMax"/>
        </c:scaling>
        <c:delete val="0"/>
        <c:axPos val="t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Helvetica" panose="020B0604020202020204" pitchFamily="34" charset="0"/>
                <a:ea typeface="+mn-ea"/>
                <a:cs typeface="Helvetica" panose="020B0604020202020204" pitchFamily="34" charset="0"/>
              </a:defRPr>
            </a:pPr>
            <a:endParaRPr lang="en-US"/>
          </a:p>
        </c:txPr>
        <c:crossAx val="924113480"/>
        <c:crosses val="autoZero"/>
        <c:crossBetween val="between"/>
      </c:valAx>
      <c:spPr>
        <a:solidFill>
          <a:schemeClr val="bg1"/>
        </a:solidFill>
        <a:ln w="31750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Helvetica" panose="020B0604020202020204" pitchFamily="34" charset="0"/>
          <a:cs typeface="Helvetica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02FD5-63DE-46B9-8B9B-7850D8D854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89F28C-0C1E-4343-9F80-D1D82676852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8F081F-1700-4706-A995-D3C892C29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A3688B-FF5C-4296-88B0-C90D5DB63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AADA59-FAE5-43BD-A354-673E576512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115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B5F957-6108-4914-9943-73ACABB93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9E442BF-1396-44E3-91AF-E10E2E5F42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59E869-B8B1-4981-A50F-CF2E34C70C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49DD0E-7ED9-4A98-B3E3-362DDAD6E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80E01C-03EF-4F14-A471-B5C51434C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164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36C780-5E92-4BFF-B823-20386CC118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087882-84EA-4203-8FD6-823F15D389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2D4DE2-2618-4D29-A1FA-B725C1375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A5C460-A96F-420D-BDAE-3C854ADA9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C16FB4-0D34-4F32-B2C6-D549F32CB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950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6453D-BCE7-457F-B787-7D05A3485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C6F32C-B9A8-4518-BDD7-B24317FD0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6445B-8074-489A-B253-4D6E6909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AEBBB9-53B7-4478-8D96-B20D5B100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7D4C60-1472-4982-9FC5-6F1B7A854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410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CFB351-E7BC-4801-B12A-C239FFE606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3638AC-D0B0-4009-9FDC-DB1506531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18399F-1C62-4D90-A816-B6B9CFE606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7FCAC2-EAA0-4DB9-A92A-A3F98A41B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9EFCF8-C163-46FA-B8FF-991CB8D96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514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46A318-4BCD-4BC6-B8DE-4F4B1095FC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0376AD-C98D-488D-AC0B-2489989789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A93E19-7519-42B0-8D11-CA65C687B2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6DE59F-50B4-4614-8614-670AA9C4E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830D01-3DA1-4014-A81C-7231B893A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FE68E1-A5FB-406F-AFD2-34A054D95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440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BE32E-0A0F-4569-9D41-AD0A1C49A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A2AD2D-A84C-412D-BA4A-AE47264D6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718F5C-1CFC-4065-A073-C3F0CAAC00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8AF287-3F8F-4D33-A065-55CE5BBAF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13ED32B-C16F-4830-A887-C8E69B59A2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443DCEC-5628-4497-94B5-38E1726EF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8DA4A59-3053-4239-A647-A4EE1049D4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EFBA1B-FDC2-42FD-8600-05DF06875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792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3D56C-1BFA-49DE-83EA-787440C184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C9FFBE-9426-4DF7-82E1-07F5F149F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60CB975-0E32-44E0-9313-7E683130C6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09BE72-A4B5-4B11-AD94-C695B562F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078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6EC99C-855F-429C-840C-A8EFB7F28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8F41FD-2869-432A-BDF6-0B1EED647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3E6439-FF97-4711-B1CB-55C7D9EDA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738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C015E-311A-4787-AB16-3711270AA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EC4CD8-EC86-4914-9EBB-AE9D4CB36C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168865-FE4F-414F-A774-F4981266E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5848C8-E714-4B09-A632-CE461BF60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B2412F-504A-40C1-9F6B-0AF12D9AC4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02468C-1B50-4C89-88DD-0CDCFDD36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865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C379F-E569-46B4-BBF2-3A443A4FD6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3A80EE-100D-43A5-AD98-EAD051510B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EFD4D6-E474-4C7A-A9E0-B672679A79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209BEF-B6D8-4C1A-9ABD-DF8E1FE474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C6AD99-3B89-471D-9A8F-9A644C275D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D5A4E6-80D2-4A2E-B1AE-BF1C9C32E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142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C8BE97-B9C1-4708-83CF-ABE5DA1143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DFAC8-869B-4244-917B-4AF737096C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E5CE2-F73E-495F-B112-99785DA532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954AD8-95F4-44FF-B9AC-5160BAF33A2D}" type="datetimeFigureOut">
              <a:rPr lang="en-US" smtClean="0"/>
              <a:t>12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55BB98-42D9-4D22-96F5-C6C97CEC2D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AEEC4E-F6D3-4A78-B971-BB03BCE192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75457-227C-48C8-B22F-241F020449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018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904DD7F-D91D-4FF2-9077-4AD032E748E2}"/>
              </a:ext>
            </a:extLst>
          </p:cNvPr>
          <p:cNvGrpSpPr/>
          <p:nvPr/>
        </p:nvGrpSpPr>
        <p:grpSpPr>
          <a:xfrm>
            <a:off x="135219" y="-181456"/>
            <a:ext cx="9782276" cy="7515225"/>
            <a:chOff x="500979" y="-172747"/>
            <a:chExt cx="9782276" cy="7515225"/>
          </a:xfrm>
        </p:grpSpPr>
        <p:graphicFrame>
          <p:nvGraphicFramePr>
            <p:cNvPr id="4" name="Chart 3">
              <a:extLst>
                <a:ext uri="{FF2B5EF4-FFF2-40B4-BE49-F238E27FC236}">
                  <a16:creationId xmlns:a16="http://schemas.microsoft.com/office/drawing/2014/main" id="{46906170-2474-4AB6-9C1D-CB2DC734B7B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13084105"/>
                </p:ext>
              </p:extLst>
            </p:nvPr>
          </p:nvGraphicFramePr>
          <p:xfrm>
            <a:off x="1020192" y="-172747"/>
            <a:ext cx="9263063" cy="75152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CA637C8-7354-443A-BFF6-4AFD518BA9DF}"/>
                </a:ext>
              </a:extLst>
            </p:cNvPr>
            <p:cNvSpPr txBox="1"/>
            <p:nvPr/>
          </p:nvSpPr>
          <p:spPr>
            <a:xfrm>
              <a:off x="5879374" y="7523"/>
              <a:ext cx="7008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Count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ECA262B-DB02-4252-BE18-D705055CD399}"/>
                </a:ext>
              </a:extLst>
            </p:cNvPr>
            <p:cNvSpPr txBox="1"/>
            <p:nvPr/>
          </p:nvSpPr>
          <p:spPr>
            <a:xfrm rot="16200000">
              <a:off x="-453321" y="3778443"/>
              <a:ext cx="243182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sz="14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  <a:p>
              <a:r>
                <a:rPr lang="en-US" sz="14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Transcription factor family</a:t>
              </a:r>
            </a:p>
          </p:txBody>
        </p:sp>
      </p:grpSp>
      <p:sp>
        <p:nvSpPr>
          <p:cNvPr id="7" name="TextBox 4">
            <a:extLst>
              <a:ext uri="{FF2B5EF4-FFF2-40B4-BE49-F238E27FC236}">
                <a16:creationId xmlns:a16="http://schemas.microsoft.com/office/drawing/2014/main" id="{9987A1FA-2034-4F0F-A76C-D0E32230AA8F}"/>
              </a:ext>
            </a:extLst>
          </p:cNvPr>
          <p:cNvSpPr txBox="1"/>
          <p:nvPr/>
        </p:nvSpPr>
        <p:spPr>
          <a:xfrm>
            <a:off x="9944774" y="88777"/>
            <a:ext cx="24512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Adhikari et al.</a:t>
            </a:r>
          </a:p>
          <a:p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Front. Genetics</a:t>
            </a:r>
          </a:p>
          <a:p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617304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4</TotalTime>
  <Words>14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ka Adhikari</dc:creator>
  <cp:lastModifiedBy>Tika</cp:lastModifiedBy>
  <cp:revision>27</cp:revision>
  <dcterms:created xsi:type="dcterms:W3CDTF">2021-04-03T12:01:21Z</dcterms:created>
  <dcterms:modified xsi:type="dcterms:W3CDTF">2021-12-12T20:53:06Z</dcterms:modified>
</cp:coreProperties>
</file>